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408" autoAdjust="0"/>
    <p:restoredTop sz="76420" autoAdjust="0"/>
  </p:normalViewPr>
  <p:slideViewPr>
    <p:cSldViewPr snapToGrid="0">
      <p:cViewPr varScale="1">
        <p:scale>
          <a:sx n="84" d="100"/>
          <a:sy n="84" d="100"/>
        </p:scale>
        <p:origin x="2034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原　悠" userId="5ca70933-9236-41ae-b51f-a8548861fb70" providerId="ADAL" clId="{BA7000DD-DEE3-40ED-A4B4-1D8AC4FEF949}"/>
    <pc:docChg chg="delSld">
      <pc:chgData name="原　悠" userId="5ca70933-9236-41ae-b51f-a8548861fb70" providerId="ADAL" clId="{BA7000DD-DEE3-40ED-A4B4-1D8AC4FEF949}" dt="2022-07-12T11:04:54.445" v="0" actId="47"/>
      <pc:docMkLst>
        <pc:docMk/>
      </pc:docMkLst>
      <pc:sldChg chg="del">
        <pc:chgData name="原　悠" userId="5ca70933-9236-41ae-b51f-a8548861fb70" providerId="ADAL" clId="{BA7000DD-DEE3-40ED-A4B4-1D8AC4FEF949}" dt="2022-07-12T11:04:54.445" v="0" actId="47"/>
        <pc:sldMkLst>
          <pc:docMk/>
          <pc:sldMk cId="736894786" sldId="26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A29706-C2D0-4086-B2F9-7ADB830FA2E7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B314E7-CECC-4570-8190-360D65AC0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794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213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6112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364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7365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4998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1255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2743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2733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087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77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583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2BD63F-26C6-4BFA-A5FA-772CFDD31CA4}" type="datetimeFigureOut">
              <a:rPr kumimoji="1" lang="ja-JP" altLang="en-US" smtClean="0"/>
              <a:t>2022/7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9DB27E-845B-4FF4-B9EA-368B1794D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002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34CDC6E-7980-4AA6-BAE5-E522ADA39F58}"/>
              </a:ext>
            </a:extLst>
          </p:cNvPr>
          <p:cNvSpPr txBox="1"/>
          <p:nvPr/>
        </p:nvSpPr>
        <p:spPr>
          <a:xfrm>
            <a:off x="1224941" y="1762808"/>
            <a:ext cx="6694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+mn-cs"/>
              </a:rPr>
              <a:t>Supplement table 1. The serum HO-1 levels according to IP subtypes 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游ゴシック" panose="020B0400000000000000" pitchFamily="50" charset="-128"/>
              <a:cs typeface="+mn-cs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7F9ED240-542E-4CB0-BB8E-04E924C2C2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9325041"/>
              </p:ext>
            </p:extLst>
          </p:nvPr>
        </p:nvGraphicFramePr>
        <p:xfrm>
          <a:off x="268662" y="2255242"/>
          <a:ext cx="8606675" cy="141665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9525">
                  <a:extLst>
                    <a:ext uri="{9D8B030D-6E8A-4147-A177-3AD203B41FA5}">
                      <a16:colId xmlns:a16="http://schemas.microsoft.com/office/drawing/2014/main" val="3843571539"/>
                    </a:ext>
                  </a:extLst>
                </a:gridCol>
                <a:gridCol w="1229525">
                  <a:extLst>
                    <a:ext uri="{9D8B030D-6E8A-4147-A177-3AD203B41FA5}">
                      <a16:colId xmlns:a16="http://schemas.microsoft.com/office/drawing/2014/main" val="3344268397"/>
                    </a:ext>
                  </a:extLst>
                </a:gridCol>
                <a:gridCol w="1229525">
                  <a:extLst>
                    <a:ext uri="{9D8B030D-6E8A-4147-A177-3AD203B41FA5}">
                      <a16:colId xmlns:a16="http://schemas.microsoft.com/office/drawing/2014/main" val="3040350943"/>
                    </a:ext>
                  </a:extLst>
                </a:gridCol>
                <a:gridCol w="1229525">
                  <a:extLst>
                    <a:ext uri="{9D8B030D-6E8A-4147-A177-3AD203B41FA5}">
                      <a16:colId xmlns:a16="http://schemas.microsoft.com/office/drawing/2014/main" val="2356185914"/>
                    </a:ext>
                  </a:extLst>
                </a:gridCol>
                <a:gridCol w="1229525">
                  <a:extLst>
                    <a:ext uri="{9D8B030D-6E8A-4147-A177-3AD203B41FA5}">
                      <a16:colId xmlns:a16="http://schemas.microsoft.com/office/drawing/2014/main" val="878259207"/>
                    </a:ext>
                  </a:extLst>
                </a:gridCol>
                <a:gridCol w="1229525">
                  <a:extLst>
                    <a:ext uri="{9D8B030D-6E8A-4147-A177-3AD203B41FA5}">
                      <a16:colId xmlns:a16="http://schemas.microsoft.com/office/drawing/2014/main" val="2178040984"/>
                    </a:ext>
                  </a:extLst>
                </a:gridCol>
                <a:gridCol w="1229525">
                  <a:extLst>
                    <a:ext uri="{9D8B030D-6E8A-4147-A177-3AD203B41FA5}">
                      <a16:colId xmlns:a16="http://schemas.microsoft.com/office/drawing/2014/main" val="3344777810"/>
                    </a:ext>
                  </a:extLst>
                </a:gridCol>
              </a:tblGrid>
              <a:tr h="431833">
                <a:tc>
                  <a:txBody>
                    <a:bodyPr/>
                    <a:lstStyle/>
                    <a:p>
                      <a:pPr algn="l"/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IP subtypes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AE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N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No AE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N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 values</a:t>
                      </a:r>
                    </a:p>
                    <a:p>
                      <a:pPr algn="ctr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AE vs. no AE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7720501"/>
                  </a:ext>
                </a:extLst>
              </a:tr>
              <a:tr h="246205">
                <a:tc rowSpan="2">
                  <a:txBody>
                    <a:bodyPr/>
                    <a:lstStyle/>
                    <a:p>
                      <a:pPr algn="l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IIPs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IPF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45.9 (27.9 - 69.4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8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5.8 (10.2 - 22.1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1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&lt; 0.001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96008945"/>
                  </a:ext>
                </a:extLst>
              </a:tr>
              <a:tr h="246205">
                <a:tc vMerge="1">
                  <a:txBody>
                    <a:bodyPr/>
                    <a:lstStyle/>
                    <a:p>
                      <a:pPr algn="ctr"/>
                      <a:endParaRPr lang="ja-JP" sz="1200" b="1" kern="100" dirty="0"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Non-IPF IIPs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8.1 (24.1 - 36.1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4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4.4 (9.9 - 25.6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7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50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3411855"/>
                  </a:ext>
                </a:extLst>
              </a:tr>
              <a:tr h="246205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SIPs</a:t>
                      </a:r>
                      <a:endParaRPr lang="ja-JP" alt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CVD-IPs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41.8 (21.9 - 53.4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7.1 (11.6 - 30.1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9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17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75916040"/>
                  </a:ext>
                </a:extLst>
              </a:tr>
              <a:tr h="246205">
                <a:tc vMerge="1">
                  <a:txBody>
                    <a:bodyPr/>
                    <a:lstStyle/>
                    <a:p>
                      <a:pPr algn="ctr"/>
                      <a:endParaRPr lang="ja-JP" sz="1200" b="1" kern="100" dirty="0"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Others</a:t>
                      </a:r>
                      <a:endParaRPr lang="ja-JP" sz="12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7.8 (16.0 - 18.7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1015" marR="6101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7359786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DF9DDD1-83BF-4633-990E-C5558A325B8B}"/>
              </a:ext>
            </a:extLst>
          </p:cNvPr>
          <p:cNvSpPr txBox="1"/>
          <p:nvPr/>
        </p:nvSpPr>
        <p:spPr>
          <a:xfrm>
            <a:off x="268663" y="3794998"/>
            <a:ext cx="86066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+mn-cs"/>
              </a:rPr>
              <a:t>Abbreviation lists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+mn-cs"/>
              </a:rPr>
              <a:t>AE, acute exacerbation; CVD, collagen vascular disease; HO-1, heme oxygenase-1; IIPs, idiopathic interstitial pneumonias; IP, interstitial pneumonia; IPF, idiopathic pulmonary fibrosis; SIPs, secondary interstitial pneumonias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dirty="0">
                <a:solidFill>
                  <a:prstClr val="black"/>
                </a:solidFill>
                <a:latin typeface="Calibri"/>
                <a:ea typeface="游ゴシック" panose="020B0400000000000000" pitchFamily="50" charset="-128"/>
              </a:rPr>
              <a:t>Footnote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+mn-cs"/>
              </a:rPr>
              <a:t>The IIPs included 49 IPF and 41 non-IPF IIPs patients including 8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+mn-cs"/>
              </a:rPr>
              <a:t>iNSIP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+mn-cs"/>
              </a:rPr>
              <a:t> diagnosed with surgical lung biopsy. The remaining non-IPF IIPs was categorized as unclassifiable IIPs.</a:t>
            </a:r>
          </a:p>
        </p:txBody>
      </p:sp>
    </p:spTree>
    <p:extLst>
      <p:ext uri="{BB962C8B-B14F-4D97-AF65-F5344CB8AC3E}">
        <p14:creationId xmlns:p14="http://schemas.microsoft.com/office/powerpoint/2010/main" val="2984525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1</TotalTime>
  <Words>157</Words>
  <Application>Microsoft Office PowerPoint</Application>
  <PresentationFormat>画面に合わせる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u hara</dc:creator>
  <cp:lastModifiedBy>原　悠</cp:lastModifiedBy>
  <cp:revision>40</cp:revision>
  <dcterms:created xsi:type="dcterms:W3CDTF">2021-10-21T01:55:05Z</dcterms:created>
  <dcterms:modified xsi:type="dcterms:W3CDTF">2022-07-12T11:05:00Z</dcterms:modified>
</cp:coreProperties>
</file>